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62" r:id="rId3"/>
    <p:sldId id="260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4" clrIdx="0">
    <p:extLst>
      <p:ext uri="{19B8F6BF-5375-455C-9EA6-DF929625EA0E}">
        <p15:presenceInfo xmlns:p15="http://schemas.microsoft.com/office/powerpoint/2012/main" userId="Microsoft Office User" providerId="None"/>
      </p:ext>
    </p:extLst>
  </p:cmAuthor>
  <p:cmAuthor id="2" name="Robert Newman" initials="RN" lastIdx="1" clrIdx="1">
    <p:extLst>
      <p:ext uri="{19B8F6BF-5375-455C-9EA6-DF929625EA0E}">
        <p15:presenceInfo xmlns:p15="http://schemas.microsoft.com/office/powerpoint/2012/main" userId="ca0df19c3f7616ca" providerId="Windows Live"/>
      </p:ext>
    </p:extLst>
  </p:cmAuthor>
  <p:cmAuthor id="3" name="Utente" initials="U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48"/>
  </p:normalViewPr>
  <p:slideViewPr>
    <p:cSldViewPr snapToGrid="0" snapToObjects="1">
      <p:cViewPr varScale="1">
        <p:scale>
          <a:sx n="114" d="100"/>
          <a:sy n="114" d="100"/>
        </p:scale>
        <p:origin x="43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2EBDA6-BBE8-8648-979F-7EE80AC784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F5C48F7-AA2F-A04C-AE11-3C00781E60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DAF07C-982E-394A-9914-3445B40E1E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3ED459-A92F-3949-A28E-10841F02C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532342-FF7E-834E-9380-14542B440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644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4DE16-9F17-9E4E-938F-4149235526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5E1B06-EC70-C349-B983-B22CF465A1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270079-A01C-E246-BAA9-C685D4F5D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DEE981-09F1-C344-B582-177C04E70F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5DF9A7-A328-D54C-9759-46CF4D292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881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EFB942-DDC4-3A46-B639-428E1D5C76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20CE31-419B-314A-BAE8-FAD35D2B7E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4389B4-9D08-B048-82EF-DEA6B743F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BBB64B-B2E7-1748-BBF3-3C3C359FC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026C72-9CFF-1542-B2F7-E82D4DAECB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854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E1DEBC-0BC4-0644-8F2D-D45055D5ED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6327F2-45F8-C04E-BC8F-02750ABE5D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767A2C-210C-2744-99F4-4EAAD8654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56FAEB-53B9-264C-8724-8B1C76F0C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9D2ED6-8255-E146-A2E5-864298322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938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83F3C-A1F8-5A4E-85F5-EA07251013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73C77E-54AD-1748-866B-2960AEEF41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941D58-7E38-6A40-94A5-019997999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4E1FE4-9737-3142-8C50-F2C85ABD54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D0290F-50AC-414B-82E2-7A6B714AF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247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BAC168-C3BB-3241-9945-DE81B29E1B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6A1002-64B2-D542-99C2-5436CE1992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32691C-F873-9947-BE11-1958EFB525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44ED46-7DC6-E344-8172-7566A6FC7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51C9D1-B36D-C74C-AB0B-DACA3273B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A223EB-1D12-BE41-989D-9CE66DB2C9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258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7F4C4C-1A02-CF4E-A4A2-8AF4AFA52E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5A9CC0-A6CF-804C-80BC-2DC532E83C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C32E33-E6A7-6140-A03E-C35DBF14B9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4286CC-43E3-EF42-9B20-EA6F5F8716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6E3D5D-80CF-D84D-A265-A4881388B4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6202EC-0784-584C-9B3A-9A5016951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69139C-AD01-D844-96DA-089737BBB8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F176EA-67D1-E943-9F48-B5311A48E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447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DE38E5-13A3-9E46-A908-A03EEB8E91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CFFF8B1-81B2-5841-93FA-7E79EA7A28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3E852D-30F6-DB47-A46D-4773F90DA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1814E9-E3B1-6145-8791-2FDD9E050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389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835E18-2879-FB4C-86C1-717868A59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29BBA2-5212-8341-95A3-BFB23A486A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96C542-889F-394B-8954-28501DBD2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311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806470-7ED1-A649-8573-2CB609927D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E6C28D-BCFA-EC43-AC55-09D014F322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71C215-5C27-5D43-9F1B-5C4B761C9B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853F31-51E6-3744-B93D-86D2CD12B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D1497C-B7BD-2C49-ACE4-75A0BE864E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0F538A-08E9-1249-B00E-72E80B56AD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433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58F95F-FB2D-A14F-9037-C2CE37105A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6E8FA73-C2AE-324C-BAAE-1562387781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24F105-F9A8-504C-A121-99A8BFF9F5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2CFB68-5024-1144-8278-A7EB24E7DE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E6CDE7-2F72-9B4B-B0E2-73220EF1F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4792F0-BEB3-B945-9938-DA2C130F9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053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BF3569-FC0C-CA44-BE95-7D26E16D48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868433-2AB9-0540-B2BA-6B2DE475A6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5C79A8-C899-9D4F-8AE2-C773FC445B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766DC-406C-4147-847D-E786D3946F60}" type="datetimeFigureOut">
              <a:rPr lang="en-US" smtClean="0"/>
              <a:pPr/>
              <a:t>7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124D75-E45D-1541-9531-42EE158004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FAD285-FF2A-A04A-906F-9FAA190969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A137F-CB1B-8740-996F-7921DC3A6D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146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po 22">
            <a:extLst>
              <a:ext uri="{FF2B5EF4-FFF2-40B4-BE49-F238E27FC236}">
                <a16:creationId xmlns:a16="http://schemas.microsoft.com/office/drawing/2014/main" id="{11AAD88E-034D-4141-B491-E224809E07CB}"/>
              </a:ext>
            </a:extLst>
          </p:cNvPr>
          <p:cNvGrpSpPr/>
          <p:nvPr/>
        </p:nvGrpSpPr>
        <p:grpSpPr>
          <a:xfrm>
            <a:off x="1791942" y="1299497"/>
            <a:ext cx="3964282" cy="2218676"/>
            <a:chOff x="419959" y="2146125"/>
            <a:chExt cx="3964282" cy="2218676"/>
          </a:xfrm>
        </p:grpSpPr>
        <p:sp>
          <p:nvSpPr>
            <p:cNvPr id="23" name="TextBox 15">
              <a:extLst>
                <a:ext uri="{FF2B5EF4-FFF2-40B4-BE49-F238E27FC236}">
                  <a16:creationId xmlns:a16="http://schemas.microsoft.com/office/drawing/2014/main" id="{E234B45B-E945-F246-B174-C58AD911E8CF}"/>
                </a:ext>
              </a:extLst>
            </p:cNvPr>
            <p:cNvSpPr txBox="1"/>
            <p:nvPr/>
          </p:nvSpPr>
          <p:spPr>
            <a:xfrm>
              <a:off x="419959" y="2668344"/>
              <a:ext cx="10548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/>
                <a:t>NF-</a:t>
              </a:r>
              <a:r>
                <a:rPr lang="en-US" sz="1400" dirty="0">
                  <a:sym typeface="Symbol" panose="05050102010706020507" pitchFamily="18" charset="2"/>
                </a:rPr>
                <a:t>B p65</a:t>
              </a:r>
              <a:endParaRPr lang="en-US" sz="1400" dirty="0"/>
            </a:p>
          </p:txBody>
        </p:sp>
        <p:sp>
          <p:nvSpPr>
            <p:cNvPr id="24" name="TextBox 16">
              <a:extLst>
                <a:ext uri="{FF2B5EF4-FFF2-40B4-BE49-F238E27FC236}">
                  <a16:creationId xmlns:a16="http://schemas.microsoft.com/office/drawing/2014/main" id="{318CA911-C45F-EC45-B714-4277248C24A9}"/>
                </a:ext>
              </a:extLst>
            </p:cNvPr>
            <p:cNvSpPr txBox="1"/>
            <p:nvPr/>
          </p:nvSpPr>
          <p:spPr>
            <a:xfrm>
              <a:off x="479114" y="3474249"/>
              <a:ext cx="995691" cy="341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/>
                <a:t>Gadd45</a:t>
              </a:r>
              <a:r>
                <a:rPr lang="el-GR" sz="1400" dirty="0"/>
                <a:t>β</a:t>
              </a:r>
              <a:r>
                <a:rPr lang="en-US" dirty="0"/>
                <a:t>  </a:t>
              </a:r>
            </a:p>
          </p:txBody>
        </p:sp>
        <p:sp>
          <p:nvSpPr>
            <p:cNvPr id="25" name="TextBox 17">
              <a:extLst>
                <a:ext uri="{FF2B5EF4-FFF2-40B4-BE49-F238E27FC236}">
                  <a16:creationId xmlns:a16="http://schemas.microsoft.com/office/drawing/2014/main" id="{F715EAD1-4B62-EF41-BBE3-EA7C6E74F7B1}"/>
                </a:ext>
              </a:extLst>
            </p:cNvPr>
            <p:cNvSpPr txBox="1"/>
            <p:nvPr/>
          </p:nvSpPr>
          <p:spPr>
            <a:xfrm>
              <a:off x="598357" y="3062161"/>
              <a:ext cx="8764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/>
                <a:t>Tubulin</a:t>
              </a:r>
              <a:r>
                <a:rPr lang="en-US" dirty="0"/>
                <a:t>  </a:t>
              </a:r>
            </a:p>
          </p:txBody>
        </p:sp>
        <p:sp>
          <p:nvSpPr>
            <p:cNvPr id="26" name="TextBox 18">
              <a:extLst>
                <a:ext uri="{FF2B5EF4-FFF2-40B4-BE49-F238E27FC236}">
                  <a16:creationId xmlns:a16="http://schemas.microsoft.com/office/drawing/2014/main" id="{D3BCE9BC-7CD7-524C-9809-57162A2A5426}"/>
                </a:ext>
              </a:extLst>
            </p:cNvPr>
            <p:cNvSpPr txBox="1"/>
            <p:nvPr/>
          </p:nvSpPr>
          <p:spPr>
            <a:xfrm>
              <a:off x="546719" y="3985551"/>
              <a:ext cx="741348" cy="341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/>
                <a:t>Tubulin</a:t>
              </a:r>
              <a:r>
                <a:rPr lang="en-US" dirty="0"/>
                <a:t>  </a:t>
              </a:r>
            </a:p>
          </p:txBody>
        </p:sp>
        <p:pic>
          <p:nvPicPr>
            <p:cNvPr id="27" name="Picture 26" descr="C:\Users\Utente\Desktop\OK01.png">
              <a:extLst>
                <a:ext uri="{FF2B5EF4-FFF2-40B4-BE49-F238E27FC236}">
                  <a16:creationId xmlns:a16="http://schemas.microsoft.com/office/drawing/2014/main" id="{F9D9E145-A4A9-4A25-85AD-A586CDDB8B4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/>
            <a:srcRect t="23101"/>
            <a:stretch>
              <a:fillRect/>
            </a:stretch>
          </p:blipFill>
          <p:spPr bwMode="auto">
            <a:xfrm>
              <a:off x="1315966" y="2583697"/>
              <a:ext cx="2822575" cy="1781104"/>
            </a:xfrm>
            <a:prstGeom prst="rect">
              <a:avLst/>
            </a:prstGeom>
            <a:noFill/>
          </p:spPr>
        </p:pic>
        <p:sp>
          <p:nvSpPr>
            <p:cNvPr id="28" name="TextBox 26">
              <a:extLst>
                <a:ext uri="{FF2B5EF4-FFF2-40B4-BE49-F238E27FC236}">
                  <a16:creationId xmlns:a16="http://schemas.microsoft.com/office/drawing/2014/main" id="{B2C0D126-EC8F-7B4A-99FC-773E1F580121}"/>
                </a:ext>
              </a:extLst>
            </p:cNvPr>
            <p:cNvSpPr txBox="1"/>
            <p:nvPr/>
          </p:nvSpPr>
          <p:spPr>
            <a:xfrm>
              <a:off x="1320247" y="2146125"/>
              <a:ext cx="151190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PBI-05204 (</a:t>
              </a:r>
              <a:r>
                <a:rPr lang="en-US" sz="1200" dirty="0">
                  <a:sym typeface="Symbol" panose="05050102010706020507" pitchFamily="18" charset="2"/>
                </a:rPr>
                <a:t>g/ml)</a:t>
              </a:r>
            </a:p>
            <a:p>
              <a:r>
                <a:rPr lang="en-US" sz="1200" dirty="0">
                  <a:sym typeface="Symbol" panose="05050102010706020507" pitchFamily="18" charset="2"/>
                </a:rPr>
                <a:t>0       0.5    1.0    5.0 </a:t>
              </a:r>
              <a:endParaRPr lang="en-US" sz="1200" dirty="0"/>
            </a:p>
          </p:txBody>
        </p:sp>
        <p:sp>
          <p:nvSpPr>
            <p:cNvPr id="29" name="TextBox 26">
              <a:extLst>
                <a:ext uri="{FF2B5EF4-FFF2-40B4-BE49-F238E27FC236}">
                  <a16:creationId xmlns:a16="http://schemas.microsoft.com/office/drawing/2014/main" id="{B2C0D126-EC8F-7B4A-99FC-773E1F580121}"/>
                </a:ext>
              </a:extLst>
            </p:cNvPr>
            <p:cNvSpPr txBox="1"/>
            <p:nvPr/>
          </p:nvSpPr>
          <p:spPr>
            <a:xfrm>
              <a:off x="2872340" y="2160209"/>
              <a:ext cx="151190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dirty="0"/>
                <a:t>PBI-05204 (</a:t>
              </a:r>
              <a:r>
                <a:rPr lang="en-US" sz="1200" dirty="0">
                  <a:sym typeface="Symbol" panose="05050102010706020507" pitchFamily="18" charset="2"/>
                </a:rPr>
                <a:t>g/ml)</a:t>
              </a:r>
            </a:p>
            <a:p>
              <a:r>
                <a:rPr lang="en-US" sz="1200" dirty="0">
                  <a:sym typeface="Symbol" panose="05050102010706020507" pitchFamily="18" charset="2"/>
                </a:rPr>
                <a:t>  0     0.5   1.0    5.0 </a:t>
              </a:r>
              <a:endParaRPr lang="en-US" sz="1200" dirty="0"/>
            </a:p>
          </p:txBody>
        </p:sp>
      </p:grpSp>
      <p:sp>
        <p:nvSpPr>
          <p:cNvPr id="21" name="TextBox 2">
            <a:extLst>
              <a:ext uri="{FF2B5EF4-FFF2-40B4-BE49-F238E27FC236}">
                <a16:creationId xmlns:a16="http://schemas.microsoft.com/office/drawing/2014/main" id="{466777F7-DEFE-9A43-8380-8536A33D0169}"/>
              </a:ext>
            </a:extLst>
          </p:cNvPr>
          <p:cNvSpPr txBox="1"/>
          <p:nvPr/>
        </p:nvSpPr>
        <p:spPr>
          <a:xfrm>
            <a:off x="1970340" y="944249"/>
            <a:ext cx="502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A</a:t>
            </a:r>
          </a:p>
        </p:txBody>
      </p:sp>
      <p:sp>
        <p:nvSpPr>
          <p:cNvPr id="22" name="TextBox 3">
            <a:extLst>
              <a:ext uri="{FF2B5EF4-FFF2-40B4-BE49-F238E27FC236}">
                <a16:creationId xmlns:a16="http://schemas.microsoft.com/office/drawing/2014/main" id="{B0D3F54E-2E71-F145-92E1-56EC87D8EF4E}"/>
              </a:ext>
            </a:extLst>
          </p:cNvPr>
          <p:cNvSpPr txBox="1"/>
          <p:nvPr/>
        </p:nvSpPr>
        <p:spPr>
          <a:xfrm>
            <a:off x="4119575" y="900906"/>
            <a:ext cx="812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A40135F-6CD2-4CD2-9743-A3E0C766C516}"/>
              </a:ext>
            </a:extLst>
          </p:cNvPr>
          <p:cNvSpPr txBox="1"/>
          <p:nvPr/>
        </p:nvSpPr>
        <p:spPr>
          <a:xfrm>
            <a:off x="738231" y="3756995"/>
            <a:ext cx="8456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. Western blot analysis of NF-</a:t>
            </a:r>
            <a:r>
              <a:rPr lang="en-US" dirty="0">
                <a:sym typeface="Symbol" panose="05050102010706020507" pitchFamily="18" charset="2"/>
              </a:rPr>
              <a:t>B p65 and Gadd45</a:t>
            </a:r>
            <a:r>
              <a:rPr lang="el-GR" dirty="0"/>
              <a:t>β</a:t>
            </a:r>
            <a:r>
              <a:rPr lang="en-US" dirty="0"/>
              <a:t> in PBI-05204 treated U87MG (A) and U251 (B) cells. </a:t>
            </a:r>
          </a:p>
        </p:txBody>
      </p:sp>
    </p:spTree>
    <p:extLst>
      <p:ext uri="{BB962C8B-B14F-4D97-AF65-F5344CB8AC3E}">
        <p14:creationId xmlns:p14="http://schemas.microsoft.com/office/powerpoint/2010/main" val="36087933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D5604BD-F31F-4A7D-B436-33A8A5FEB2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8894" y="1315453"/>
            <a:ext cx="5188254" cy="389119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106A8A0-4E44-4D2E-B61B-8348E8987620}"/>
              </a:ext>
            </a:extLst>
          </p:cNvPr>
          <p:cNvSpPr txBox="1"/>
          <p:nvPr/>
        </p:nvSpPr>
        <p:spPr>
          <a:xfrm>
            <a:off x="1048624" y="5426404"/>
            <a:ext cx="8456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2. Terminal body weight of mice bearing U87MG xenograft treated with PBI-05204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FD2A64F-7219-4C19-B719-C79665FD2BBE}"/>
              </a:ext>
            </a:extLst>
          </p:cNvPr>
          <p:cNvSpPr txBox="1"/>
          <p:nvPr/>
        </p:nvSpPr>
        <p:spPr>
          <a:xfrm>
            <a:off x="1979802" y="2121140"/>
            <a:ext cx="461665" cy="171300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dirty="0"/>
              <a:t>Body weight (g)</a:t>
            </a:r>
          </a:p>
        </p:txBody>
      </p:sp>
    </p:spTree>
    <p:extLst>
      <p:ext uri="{BB962C8B-B14F-4D97-AF65-F5344CB8AC3E}">
        <p14:creationId xmlns:p14="http://schemas.microsoft.com/office/powerpoint/2010/main" val="21834516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37FAAE8-0DEA-D94E-9ADA-5734E54D41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1553014"/>
              </p:ext>
            </p:extLst>
          </p:nvPr>
        </p:nvGraphicFramePr>
        <p:xfrm>
          <a:off x="1829617" y="796923"/>
          <a:ext cx="9128895" cy="486951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016876">
                  <a:extLst>
                    <a:ext uri="{9D8B030D-6E8A-4147-A177-3AD203B41FA5}">
                      <a16:colId xmlns:a16="http://schemas.microsoft.com/office/drawing/2014/main" val="1693728972"/>
                    </a:ext>
                  </a:extLst>
                </a:gridCol>
                <a:gridCol w="1580946">
                  <a:extLst>
                    <a:ext uri="{9D8B030D-6E8A-4147-A177-3AD203B41FA5}">
                      <a16:colId xmlns:a16="http://schemas.microsoft.com/office/drawing/2014/main" val="1571230183"/>
                    </a:ext>
                  </a:extLst>
                </a:gridCol>
                <a:gridCol w="1738145">
                  <a:extLst>
                    <a:ext uri="{9D8B030D-6E8A-4147-A177-3AD203B41FA5}">
                      <a16:colId xmlns:a16="http://schemas.microsoft.com/office/drawing/2014/main" val="390342381"/>
                    </a:ext>
                  </a:extLst>
                </a:gridCol>
                <a:gridCol w="1896464">
                  <a:extLst>
                    <a:ext uri="{9D8B030D-6E8A-4147-A177-3AD203B41FA5}">
                      <a16:colId xmlns:a16="http://schemas.microsoft.com/office/drawing/2014/main" val="349357519"/>
                    </a:ext>
                  </a:extLst>
                </a:gridCol>
                <a:gridCol w="1896464">
                  <a:extLst>
                    <a:ext uri="{9D8B030D-6E8A-4147-A177-3AD203B41FA5}">
                      <a16:colId xmlns:a16="http://schemas.microsoft.com/office/drawing/2014/main" val="113704163"/>
                    </a:ext>
                  </a:extLst>
                </a:gridCol>
              </a:tblGrid>
              <a:tr h="324597">
                <a:tc>
                  <a:txBody>
                    <a:bodyPr/>
                    <a:lstStyle/>
                    <a:p>
                      <a:pPr marL="0" marR="0" indent="269875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 gridSpan="4"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251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8901388"/>
                  </a:ext>
                </a:extLst>
              </a:tr>
              <a:tr h="901551"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kers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hicle</a:t>
                      </a: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RL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BI-05204 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 mg/Kg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BI-05204 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0 mg/Kg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BI-05204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40 mg/Kg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extLst>
                  <a:ext uri="{0D108BD9-81ED-4DB2-BD59-A6C34878D82A}">
                    <a16:rowId xmlns:a16="http://schemas.microsoft.com/office/drawing/2014/main" val="360533560"/>
                  </a:ext>
                </a:extLst>
              </a:tr>
              <a:tr h="901551"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ssel count</a:t>
                      </a:r>
                    </a:p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entage of CD31+ vessels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4 ± 4.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7 ± 3.5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 ± 2.4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0 ± 1.0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extLst>
                  <a:ext uri="{0D108BD9-81ED-4DB2-BD59-A6C34878D82A}">
                    <a16:rowId xmlns:a16="http://schemas.microsoft.com/office/drawing/2014/main" val="1415552330"/>
                  </a:ext>
                </a:extLst>
              </a:tr>
              <a:tr h="586025"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entage of Ki67+ cells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7± 8.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4 ± 2.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2 ± 2.4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5 ± 2.8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extLst>
                  <a:ext uri="{0D108BD9-81ED-4DB2-BD59-A6C34878D82A}">
                    <a16:rowId xmlns:a16="http://schemas.microsoft.com/office/drawing/2014/main" val="501427221"/>
                  </a:ext>
                </a:extLst>
              </a:tr>
              <a:tr h="1217077"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ptosis. percentage of tunnel positive cells (%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2%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5 ± 2.5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0 ± 3.0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7 ± 7.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extLst>
                  <a:ext uri="{0D108BD9-81ED-4DB2-BD59-A6C34878D82A}">
                    <a16:rowId xmlns:a16="http://schemas.microsoft.com/office/drawing/2014/main" val="1247825013"/>
                  </a:ext>
                </a:extLst>
              </a:tr>
              <a:tr h="901551"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crosis </a:t>
                      </a:r>
                    </a:p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entage(%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2%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 ± 2.5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 ± 2.5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9 ± 6.5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927" marR="63927" marT="0" marB="0"/>
                </a:tc>
                <a:extLst>
                  <a:ext uri="{0D108BD9-81ED-4DB2-BD59-A6C34878D82A}">
                    <a16:rowId xmlns:a16="http://schemas.microsoft.com/office/drawing/2014/main" val="3397495828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3047D360-4E63-B349-B1C0-6FB773A8F6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4836" y="35176"/>
            <a:ext cx="11007163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. </a:t>
            </a: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ohistochemical evaluation on markers of proliferation, apoptosis, and angiogenesis in vehicle treated (control)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PBI-05204 treated U251 xenografts</a:t>
            </a:r>
            <a:endParaRPr kumimoji="0" lang="en-US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8F177E4-501F-2D4B-94BF-3A48075C1CC8}"/>
              </a:ext>
            </a:extLst>
          </p:cNvPr>
          <p:cNvSpPr txBox="1"/>
          <p:nvPr/>
        </p:nvSpPr>
        <p:spPr>
          <a:xfrm>
            <a:off x="2271713" y="5731398"/>
            <a:ext cx="4829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P &lt; 0.05</a:t>
            </a:r>
          </a:p>
        </p:txBody>
      </p:sp>
    </p:spTree>
    <p:extLst>
      <p:ext uri="{BB962C8B-B14F-4D97-AF65-F5344CB8AC3E}">
        <p14:creationId xmlns:p14="http://schemas.microsoft.com/office/powerpoint/2010/main" val="5488241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FE4BB8A-4056-564E-83C0-ACD9D276C5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127029"/>
              </p:ext>
            </p:extLst>
          </p:nvPr>
        </p:nvGraphicFramePr>
        <p:xfrm>
          <a:off x="1867534" y="989457"/>
          <a:ext cx="8419467" cy="449674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860138">
                  <a:extLst>
                    <a:ext uri="{9D8B030D-6E8A-4147-A177-3AD203B41FA5}">
                      <a16:colId xmlns:a16="http://schemas.microsoft.com/office/drawing/2014/main" val="1075156152"/>
                    </a:ext>
                  </a:extLst>
                </a:gridCol>
                <a:gridCol w="1458086">
                  <a:extLst>
                    <a:ext uri="{9D8B030D-6E8A-4147-A177-3AD203B41FA5}">
                      <a16:colId xmlns:a16="http://schemas.microsoft.com/office/drawing/2014/main" val="2783216747"/>
                    </a:ext>
                  </a:extLst>
                </a:gridCol>
                <a:gridCol w="1603071">
                  <a:extLst>
                    <a:ext uri="{9D8B030D-6E8A-4147-A177-3AD203B41FA5}">
                      <a16:colId xmlns:a16="http://schemas.microsoft.com/office/drawing/2014/main" val="618679158"/>
                    </a:ext>
                  </a:extLst>
                </a:gridCol>
                <a:gridCol w="1749086">
                  <a:extLst>
                    <a:ext uri="{9D8B030D-6E8A-4147-A177-3AD203B41FA5}">
                      <a16:colId xmlns:a16="http://schemas.microsoft.com/office/drawing/2014/main" val="164716119"/>
                    </a:ext>
                  </a:extLst>
                </a:gridCol>
                <a:gridCol w="1749086">
                  <a:extLst>
                    <a:ext uri="{9D8B030D-6E8A-4147-A177-3AD203B41FA5}">
                      <a16:colId xmlns:a16="http://schemas.microsoft.com/office/drawing/2014/main" val="2589648081"/>
                    </a:ext>
                  </a:extLst>
                </a:gridCol>
              </a:tblGrid>
              <a:tr h="309746">
                <a:tc>
                  <a:txBody>
                    <a:bodyPr/>
                    <a:lstStyle/>
                    <a:p>
                      <a:pPr marL="0" marR="0" indent="269875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4"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98G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51817551"/>
                  </a:ext>
                </a:extLst>
              </a:tr>
              <a:tr h="669915"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ker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hicle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RL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BI-05204 (10 mg/Kg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BI-05204 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0 mg/Kg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BI-05204 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0 mg/Kg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90055024"/>
                  </a:ext>
                </a:extLst>
              </a:tr>
              <a:tr h="1030085"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ssel count</a:t>
                      </a:r>
                    </a:p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entage of CD31+ vessels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8 ± 5.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5 ± 3.5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 ± 2.0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 ± 2.5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56149955"/>
                  </a:ext>
                </a:extLst>
              </a:tr>
              <a:tr h="669915"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entage of Ki67+ cells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5 ± 9.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7 ± 3.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0 ± 2.5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0 ± 2.8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72736536"/>
                  </a:ext>
                </a:extLst>
              </a:tr>
              <a:tr h="846667"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ptosis. percentage of tunnel positive cells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2%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 ± 2.0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5 ± 4.0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 ± 5.5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63983758"/>
                  </a:ext>
                </a:extLst>
              </a:tr>
              <a:tr h="669915"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crosis percentage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± 1.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 ± 1.5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8 ± 3.5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26987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5 ± 4.0*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38954136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1E0E8AA0-1567-A54E-83CB-F45CA1398A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7364" y="328276"/>
            <a:ext cx="9511148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269875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269875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2. Immunohistochemical evaluation on markers of proliferation, apoptosis, and angiogenesis, in vehicle (control)    and PBI-05204 treated T98G xenografts</a:t>
            </a:r>
            <a:endParaRPr kumimoji="0" lang="en-US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8FBB5AA-37B9-CA41-A8A9-C85986CF2A6D}"/>
              </a:ext>
            </a:extLst>
          </p:cNvPr>
          <p:cNvSpPr txBox="1"/>
          <p:nvPr/>
        </p:nvSpPr>
        <p:spPr>
          <a:xfrm>
            <a:off x="2500313" y="5486199"/>
            <a:ext cx="4829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P &lt; 0.05</a:t>
            </a:r>
          </a:p>
        </p:txBody>
      </p:sp>
    </p:spTree>
    <p:extLst>
      <p:ext uri="{BB962C8B-B14F-4D97-AF65-F5344CB8AC3E}">
        <p14:creationId xmlns:p14="http://schemas.microsoft.com/office/powerpoint/2010/main" val="29615221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</TotalTime>
  <Words>347</Words>
  <Application>Microsoft Office PowerPoint</Application>
  <PresentationFormat>Widescreen</PresentationFormat>
  <Paragraphs>8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Peiying Yang</cp:lastModifiedBy>
  <cp:revision>19</cp:revision>
  <dcterms:created xsi:type="dcterms:W3CDTF">2019-10-01T15:46:37Z</dcterms:created>
  <dcterms:modified xsi:type="dcterms:W3CDTF">2020-07-31T04:49:28Z</dcterms:modified>
</cp:coreProperties>
</file>